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AF3B3F-2CC0-4401-B16D-FEAE32BB8E3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C7EBA3-67D5-4AFC-8898-EF0F5B65519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013743-00AC-4694-828E-6348877C814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374907-398F-446D-A889-78F5E3A405C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25FB47-DB5C-4472-A904-1E06BAD0E62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61AAFE-0AB4-4D5D-AB31-F9EBF9F2FC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3EAEF-5088-45DB-AB23-D1145AFFD4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AEC51-9A36-4D30-884A-9B62D21846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A2520-3CDB-4017-9809-C042A329C0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864B0-B20D-476F-B860-C6A3756902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332BC0-32C6-4181-8A96-7BC81E8F12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B23F6-62ED-4D63-8425-5EAF58979D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2B92D-DA1A-4A06-B0F1-629FB9A1BF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547836-EAC2-48A7-A36F-2248AF5AB3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BF216E-7BEA-41FE-909B-92A0B652FE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8E03C-1036-47A4-9407-FE2FEA97E6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B03518-EBA6-47CA-AC44-742B659640F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0"/>
          <p:cNvGrpSpPr/>
          <p:nvPr/>
        </p:nvGrpSpPr>
        <p:grpSpPr>
          <a:xfrm>
            <a:off x="206280" y="304920"/>
            <a:ext cx="8590680" cy="5029200"/>
            <a:chOff x="206280" y="304920"/>
            <a:chExt cx="8590680" cy="5029200"/>
          </a:xfrm>
        </p:grpSpPr>
        <p:pic>
          <p:nvPicPr>
            <p:cNvPr id="49" name="Picture 2" descr=""/>
            <p:cNvPicPr/>
            <p:nvPr/>
          </p:nvPicPr>
          <p:blipFill>
            <a:blip r:embed="rId1"/>
            <a:srcRect l="29194" t="6410" r="29035" b="3839"/>
            <a:stretch/>
          </p:blipFill>
          <p:spPr>
            <a:xfrm>
              <a:off x="2542320" y="990720"/>
              <a:ext cx="3580920" cy="434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5"/>
            <p:cNvSpPr/>
            <p:nvPr/>
          </p:nvSpPr>
          <p:spPr>
            <a:xfrm>
              <a:off x="787320" y="304920"/>
              <a:ext cx="80096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Calibri"/>
                </a:rPr>
                <a:t>A. Sequence distribution: biological process (filtered by # seqs: cutoff: 5.0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6"/>
            <p:cNvSpPr/>
            <p:nvPr/>
          </p:nvSpPr>
          <p:spPr>
            <a:xfrm>
              <a:off x="367560" y="1244520"/>
              <a:ext cx="2147400" cy="580680"/>
            </a:xfrm>
            <a:prstGeom prst="rect">
              <a:avLst/>
            </a:pr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Paclitaxel biosynthetic process (5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7"/>
            <p:cNvSpPr/>
            <p:nvPr/>
          </p:nvSpPr>
          <p:spPr>
            <a:xfrm>
              <a:off x="6121080" y="1295280"/>
              <a:ext cx="2306520" cy="580680"/>
            </a:xfrm>
            <a:prstGeom prst="rect">
              <a:avLst/>
            </a:pr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Small molecule biosynthetic process (5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8"/>
            <p:cNvSpPr/>
            <p:nvPr/>
          </p:nvSpPr>
          <p:spPr>
            <a:xfrm>
              <a:off x="206280" y="3852720"/>
              <a:ext cx="2331720" cy="337320"/>
            </a:xfrm>
            <a:prstGeom prst="rect">
              <a:avLst/>
            </a:pr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Response to stimulus (8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9"/>
            <p:cNvSpPr/>
            <p:nvPr/>
          </p:nvSpPr>
          <p:spPr>
            <a:xfrm>
              <a:off x="6137280" y="4191120"/>
              <a:ext cx="2473920" cy="337320"/>
            </a:xfrm>
            <a:prstGeom prst="rect">
              <a:avLst/>
            </a:pr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Oxidation reduction (10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oup 10"/>
          <p:cNvGrpSpPr/>
          <p:nvPr/>
        </p:nvGrpSpPr>
        <p:grpSpPr>
          <a:xfrm>
            <a:off x="304920" y="392040"/>
            <a:ext cx="8454960" cy="5551560"/>
            <a:chOff x="304920" y="392040"/>
            <a:chExt cx="8454960" cy="5551560"/>
          </a:xfrm>
        </p:grpSpPr>
        <p:sp>
          <p:nvSpPr>
            <p:cNvPr id="56" name="TextBox 3"/>
            <p:cNvSpPr/>
            <p:nvPr/>
          </p:nvSpPr>
          <p:spPr>
            <a:xfrm>
              <a:off x="636120" y="392040"/>
              <a:ext cx="81237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Calibri"/>
                </a:rPr>
                <a:t>B. Sequence distribution: molecular function (filtered by # seqs: cutoff: 5.0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7" name="Picture 2" descr="C:\SSH\Molecular Function 1.png"/>
            <p:cNvPicPr/>
            <p:nvPr/>
          </p:nvPicPr>
          <p:blipFill>
            <a:blip r:embed="rId1"/>
            <a:srcRect l="23745" t="9095" r="23774" b="4863"/>
            <a:stretch/>
          </p:blipFill>
          <p:spPr>
            <a:xfrm>
              <a:off x="2899800" y="935280"/>
              <a:ext cx="3958200" cy="5008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TextBox 6"/>
            <p:cNvSpPr/>
            <p:nvPr/>
          </p:nvSpPr>
          <p:spPr>
            <a:xfrm>
              <a:off x="380880" y="1371600"/>
              <a:ext cx="2514600" cy="337320"/>
            </a:xfrm>
            <a:prstGeom prst="rect">
              <a:avLst/>
            </a:pr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Transferase activity (5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7"/>
            <p:cNvSpPr/>
            <p:nvPr/>
          </p:nvSpPr>
          <p:spPr>
            <a:xfrm>
              <a:off x="304920" y="5257800"/>
              <a:ext cx="2590560" cy="337320"/>
            </a:xfrm>
            <a:prstGeom prst="rect">
              <a:avLst/>
            </a:pr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Oxidoreductase activity (16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9"/>
            <p:cNvSpPr/>
            <p:nvPr/>
          </p:nvSpPr>
          <p:spPr>
            <a:xfrm>
              <a:off x="6858000" y="1981080"/>
              <a:ext cx="1523880" cy="337320"/>
            </a:xfrm>
            <a:prstGeom prst="rect">
              <a:avLst/>
            </a:pr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Iron binding (9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Group 8"/>
          <p:cNvGrpSpPr/>
          <p:nvPr/>
        </p:nvGrpSpPr>
        <p:grpSpPr>
          <a:xfrm>
            <a:off x="609480" y="380880"/>
            <a:ext cx="8458200" cy="5951520"/>
            <a:chOff x="609480" y="380880"/>
            <a:chExt cx="8458200" cy="5951520"/>
          </a:xfrm>
        </p:grpSpPr>
        <p:sp>
          <p:nvSpPr>
            <p:cNvPr id="62" name="Rectangle 3"/>
            <p:cNvSpPr/>
            <p:nvPr/>
          </p:nvSpPr>
          <p:spPr>
            <a:xfrm>
              <a:off x="609480" y="380880"/>
              <a:ext cx="822960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Calibri"/>
                </a:rPr>
                <a:t>C. Sequence distribution: cellular component (filtered by # seqs: cutoff: 5.0)</a:t>
              </a:r>
              <a:endParaRPr b="0" lang="en-US" sz="2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3" name="Picture 2" descr="C:\SSH\Cellular component1.png"/>
            <p:cNvPicPr/>
            <p:nvPr/>
          </p:nvPicPr>
          <p:blipFill>
            <a:blip r:embed="rId1"/>
            <a:srcRect l="23918" t="22245" r="23445" b="9569"/>
            <a:stretch/>
          </p:blipFill>
          <p:spPr>
            <a:xfrm>
              <a:off x="2869920" y="1142640"/>
              <a:ext cx="3835440" cy="5189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TextBox 5"/>
            <p:cNvSpPr/>
            <p:nvPr/>
          </p:nvSpPr>
          <p:spPr>
            <a:xfrm>
              <a:off x="914040" y="2057400"/>
              <a:ext cx="1963800" cy="337320"/>
            </a:xfrm>
            <a:prstGeom prst="rect">
              <a:avLst/>
            </a:pr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Cytoplasmic part (5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6"/>
            <p:cNvSpPr/>
            <p:nvPr/>
          </p:nvSpPr>
          <p:spPr>
            <a:xfrm>
              <a:off x="1461960" y="5375520"/>
              <a:ext cx="1419120" cy="337320"/>
            </a:xfrm>
            <a:prstGeom prst="rect">
              <a:avLst/>
            </a:pr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Membrane (6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7"/>
            <p:cNvSpPr/>
            <p:nvPr/>
          </p:nvSpPr>
          <p:spPr>
            <a:xfrm>
              <a:off x="6705720" y="2666880"/>
              <a:ext cx="2361960" cy="337320"/>
            </a:xfrm>
            <a:prstGeom prst="rect">
              <a:avLst/>
            </a:prstGeom>
            <a:noFill/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</a:rPr>
                <a:t>Intracellular organelle (5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27T15:25:15Z</dcterms:created>
  <dc:creator>ELW</dc:creator>
  <dc:description/>
  <dc:language>en-US</dc:language>
  <cp:lastModifiedBy>ELW</cp:lastModifiedBy>
  <dcterms:modified xsi:type="dcterms:W3CDTF">2011-08-12T15:32:38Z</dcterms:modified>
  <cp:revision>14</cp:revision>
  <dc:subject/>
  <dc:title>PowerPoint Presentation</dc:title>
</cp:coreProperties>
</file>